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2828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7546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5487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5798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9340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8317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7400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3680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134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6820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7924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F9FBE-4C2F-4261-8BD1-D7B0F2DF2C10}" type="datetimeFigureOut">
              <a:rPr lang="ko-KR" altLang="en-US" smtClean="0"/>
              <a:t>2020-12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C7A53-656E-4B9E-BBE1-FD9AADE3E1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5706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04900" y="6318836"/>
            <a:ext cx="11087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/>
              <a:t>A: Anatomy, B</a:t>
            </a:r>
            <a:r>
              <a:rPr lang="en-US" altLang="ko-KR" sz="1600" smtClean="0"/>
              <a:t>: Biochemistry</a:t>
            </a:r>
            <a:r>
              <a:rPr lang="en-US" altLang="ko-KR" sz="1600" dirty="0" smtClean="0"/>
              <a:t>, C: Histology, D: Gastrointestinal system E: Respiratory system, F: Circulatory system</a:t>
            </a:r>
            <a:endParaRPr lang="ko-KR" altLang="en-US" sz="1600" dirty="0"/>
          </a:p>
        </p:txBody>
      </p:sp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2383821"/>
              </p:ext>
            </p:extLst>
          </p:nvPr>
        </p:nvGraphicFramePr>
        <p:xfrm>
          <a:off x="1483175" y="0"/>
          <a:ext cx="9888636" cy="6490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5" r:id="rId3" imgW="9324000" imgH="6120000" progId="Prism5.Document">
                  <p:embed/>
                </p:oleObj>
              </mc:Choice>
              <mc:Fallback>
                <p:oleObj name="Prism 5" r:id="rId3" imgW="9324000" imgH="612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83175" y="0"/>
                        <a:ext cx="9888636" cy="6490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77115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5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Office 테마</vt:lpstr>
      <vt:lpstr>Prism 5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owner</cp:lastModifiedBy>
  <cp:revision>4</cp:revision>
  <dcterms:created xsi:type="dcterms:W3CDTF">2020-10-22T09:28:31Z</dcterms:created>
  <dcterms:modified xsi:type="dcterms:W3CDTF">2020-12-04T08:58:06Z</dcterms:modified>
</cp:coreProperties>
</file>